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4" r:id="rId3"/>
    <p:sldId id="265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BC89EF96-8CEA-46FF-86C4-4CE0E7609802}" styleName="浅色样式 3 - 强调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57" autoAdjust="0"/>
    <p:restoredTop sz="93433" autoAdjust="0"/>
  </p:normalViewPr>
  <p:slideViewPr>
    <p:cSldViewPr snapToGrid="0">
      <p:cViewPr>
        <p:scale>
          <a:sx n="60" d="100"/>
          <a:sy n="60" d="100"/>
        </p:scale>
        <p:origin x="-1062" y="-21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475CD393-1C64-40B5-A079-F26914980C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="" xmlns:a16="http://schemas.microsoft.com/office/drawing/2014/main" id="{02E7EF5C-4CAC-41F1-96EA-8E3C83B393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BD24CE00-86A9-42DA-9A55-FA645E8397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11214-180D-4F7C-93A3-291B3030CCFD}" type="datetimeFigureOut">
              <a:rPr lang="zh-CN" altLang="en-US" smtClean="0"/>
              <a:t>2022/10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5FC6DB4D-8475-4D19-93F3-8F957BD1C5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A87BC343-B6FB-4A21-9219-B2ED5891F8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7D51C-68E3-4FF5-BDB8-5C74FB4AA3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4460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40C0F745-4374-4F23-86CE-C7F17A8D23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150033F8-0113-4861-8ADE-49369B1BE1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45A8B07A-32D6-465A-94C5-579C4F73A8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11214-180D-4F7C-93A3-291B3030CCFD}" type="datetimeFigureOut">
              <a:rPr lang="zh-CN" altLang="en-US" smtClean="0"/>
              <a:t>2022/10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CF250C99-7DF0-459F-A07D-1555E4CA55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42BF92FF-1AFD-4AE9-9F02-724A3DD465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7D51C-68E3-4FF5-BDB8-5C74FB4AA3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19714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="" xmlns:a16="http://schemas.microsoft.com/office/drawing/2014/main" id="{F7DD26E9-64E8-483A-A717-187EC86E64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BB6B82EA-DBC6-482C-B014-F6E80A43AE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FC0C6D47-D4D7-4CD0-ADD4-D2FCB60825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11214-180D-4F7C-93A3-291B3030CCFD}" type="datetimeFigureOut">
              <a:rPr lang="zh-CN" altLang="en-US" smtClean="0"/>
              <a:t>2022/10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FB476627-6805-41E2-BD49-48D45D7A7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9190DBA5-1CC1-4ACE-980C-6661E51526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7D51C-68E3-4FF5-BDB8-5C74FB4AA3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87275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8D79C1C8-1B4E-46A5-91A0-374E690FF8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D18EC0BA-89C9-4B8B-88C9-205FC6DAB9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F9BD9F4E-50E3-4A5F-9F54-67181C522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11214-180D-4F7C-93A3-291B3030CCFD}" type="datetimeFigureOut">
              <a:rPr lang="zh-CN" altLang="en-US" smtClean="0"/>
              <a:t>2022/10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3A98DC45-B81F-46D3-9789-2B0361E41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EAEB0A53-1768-4B82-AA83-F5C97FBDDC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7D51C-68E3-4FF5-BDB8-5C74FB4AA3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9901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A96D2FDB-E04F-4FCB-AF00-1C58B6375D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0F18D4EA-AB1E-4BA9-BAA7-A603CD9E2F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48886DC0-3748-4162-BA76-7E8F7C8B9B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11214-180D-4F7C-93A3-291B3030CCFD}" type="datetimeFigureOut">
              <a:rPr lang="zh-CN" altLang="en-US" smtClean="0"/>
              <a:t>2022/10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879343E6-A3CC-424F-9216-F24C7D243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4C8BCE48-3E45-4723-A655-179B7A67CC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7D51C-68E3-4FF5-BDB8-5C74FB4AA3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87941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86A96ABC-9CEE-4E5A-AE47-7FFB7662D2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02311E1C-25AA-4B80-BC23-7E3EA9F1774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0E263B21-902E-4788-89C9-AEDAF0E774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5F985117-B040-422B-B445-76B11E47B5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11214-180D-4F7C-93A3-291B3030CCFD}" type="datetimeFigureOut">
              <a:rPr lang="zh-CN" altLang="en-US" smtClean="0"/>
              <a:t>2022/10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AD3871BF-43B5-4AF2-AA42-1538CC581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FF1D319A-5595-4BD5-8ECF-12B045439E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7D51C-68E3-4FF5-BDB8-5C74FB4AA3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03857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85E7AB42-2074-4DA7-8ABF-ACB23CE039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718D48BB-DC18-4398-85CF-433034558F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1C73D145-CFFF-4D55-84E3-EE4CE0DA59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="" xmlns:a16="http://schemas.microsoft.com/office/drawing/2014/main" id="{CE95579F-41BB-4795-97B6-24B535D0FB1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="" xmlns:a16="http://schemas.microsoft.com/office/drawing/2014/main" id="{2B57F680-4467-459B-B259-42EF6B2183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="" xmlns:a16="http://schemas.microsoft.com/office/drawing/2014/main" id="{DCAD4553-2667-4737-8170-39DF08879F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11214-180D-4F7C-93A3-291B3030CCFD}" type="datetimeFigureOut">
              <a:rPr lang="zh-CN" altLang="en-US" smtClean="0"/>
              <a:t>2022/10/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="" xmlns:a16="http://schemas.microsoft.com/office/drawing/2014/main" id="{1D132B65-3DB4-4381-A7AE-3A5A9280E1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="" xmlns:a16="http://schemas.microsoft.com/office/drawing/2014/main" id="{A93D66F8-51E2-436F-8464-DC87CAC3A3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7D51C-68E3-4FF5-BDB8-5C74FB4AA3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1482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87FFD765-0BB1-4DC4-9E97-738254F9E7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="" xmlns:a16="http://schemas.microsoft.com/office/drawing/2014/main" id="{6CE67356-F359-4F45-9CFF-B03F93BE8F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11214-180D-4F7C-93A3-291B3030CCFD}" type="datetimeFigureOut">
              <a:rPr lang="zh-CN" altLang="en-US" smtClean="0"/>
              <a:t>2022/10/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="" xmlns:a16="http://schemas.microsoft.com/office/drawing/2014/main" id="{6BE37087-388F-482E-A2FD-CEAE86AA6D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="" xmlns:a16="http://schemas.microsoft.com/office/drawing/2014/main" id="{AE4BEB2C-FA67-43DD-BB6A-F26753FC9D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7D51C-68E3-4FF5-BDB8-5C74FB4AA3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36060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="" xmlns:a16="http://schemas.microsoft.com/office/drawing/2014/main" id="{43AA2698-3FFC-4E02-91EC-7FA9A6DE77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11214-180D-4F7C-93A3-291B3030CCFD}" type="datetimeFigureOut">
              <a:rPr lang="zh-CN" altLang="en-US" smtClean="0"/>
              <a:t>2022/10/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="" xmlns:a16="http://schemas.microsoft.com/office/drawing/2014/main" id="{785B83C0-37AE-4D48-BD1A-AD63CC24B9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="" xmlns:a16="http://schemas.microsoft.com/office/drawing/2014/main" id="{D0E16FE3-98DE-4F3C-ABAA-1E6ECD2EC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7D51C-68E3-4FF5-BDB8-5C74FB4AA3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6052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391CE87C-C698-4534-A747-CBBB499048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0BE05C26-CD7F-47B5-AE2A-70A882EC1B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8D9FF1CC-CF2B-48DD-A2FC-33CC93F470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29E4AD5A-5B0A-4A73-BF55-5D3D535D9E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11214-180D-4F7C-93A3-291B3030CCFD}" type="datetimeFigureOut">
              <a:rPr lang="zh-CN" altLang="en-US" smtClean="0"/>
              <a:t>2022/10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B46FEE84-7CA5-4402-A8F9-DBA2BF3246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A0B8B0FC-2970-43FC-83E4-505A2B91B7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7D51C-68E3-4FF5-BDB8-5C74FB4AA3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9189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C504E5DD-1E60-4253-BEA5-B1E55056B6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="" xmlns:a16="http://schemas.microsoft.com/office/drawing/2014/main" id="{8219A193-9015-4599-8970-0CA42D92275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7E844938-60DB-468A-B775-DE501D11FF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86966328-DEB5-484C-9135-11BAD2E04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11214-180D-4F7C-93A3-291B3030CCFD}" type="datetimeFigureOut">
              <a:rPr lang="zh-CN" altLang="en-US" smtClean="0"/>
              <a:t>2022/10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09FF6E0F-BB31-4CDC-96D3-E0B88DC8C7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81BC24DF-2C84-48AD-8B7C-F03562BE1C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E7D51C-68E3-4FF5-BDB8-5C74FB4AA3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4077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="" xmlns:a16="http://schemas.microsoft.com/office/drawing/2014/main" id="{10FACF39-AFCB-4D21-B51F-7AD5BB551C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9A4D9612-95E1-4D85-A4B3-D2B0095882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B0D0FCD6-C1DF-466F-AC0B-9343E587251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811214-180D-4F7C-93A3-291B3030CCFD}" type="datetimeFigureOut">
              <a:rPr lang="zh-CN" altLang="en-US" smtClean="0"/>
              <a:t>2022/10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ABB9054C-5E42-4BAC-A0B6-A0A341F6FF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D7961EFE-6826-44BC-AB92-FB7AC5FA42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E7D51C-68E3-4FF5-BDB8-5C74FB4AA3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3174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28">
            <a:extLst>
              <a:ext uri="{FF2B5EF4-FFF2-40B4-BE49-F238E27FC236}">
                <a16:creationId xmlns="" xmlns:a16="http://schemas.microsoft.com/office/drawing/2014/main" id="{107037E9-54B9-44D9-A3DE-5C4308F8DCD2}"/>
              </a:ext>
            </a:extLst>
          </p:cNvPr>
          <p:cNvSpPr txBox="1"/>
          <p:nvPr/>
        </p:nvSpPr>
        <p:spPr>
          <a:xfrm>
            <a:off x="102367" y="79416"/>
            <a:ext cx="1198803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</a:t>
            </a:r>
            <a:r>
              <a:rPr lang="en-US" altLang="zh-CN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1  Characteristics of the airborne bacterial aerosol concentration in the broiler house (A) and size distribution of bacterial particles in the broiler house (B). </a:t>
            </a:r>
            <a:endParaRPr lang="zh-CN" altLang="en-US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6212" y="1209279"/>
            <a:ext cx="4237037" cy="1431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6213" y="2815915"/>
            <a:ext cx="7218607" cy="20338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0" name="Picture 4" descr="C:\Users\lenovon\Desktop\Data 1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367" y="1348598"/>
            <a:ext cx="4483100" cy="45354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9644692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7296" y="66429"/>
            <a:ext cx="1266825" cy="447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4121" y="66429"/>
            <a:ext cx="6813550" cy="67915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右箭头 3"/>
          <p:cNvSpPr/>
          <p:nvPr/>
        </p:nvSpPr>
        <p:spPr>
          <a:xfrm>
            <a:off x="893549" y="2569028"/>
            <a:ext cx="580572" cy="319314"/>
          </a:xfrm>
          <a:prstGeom prst="rightArrow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31350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7227261"/>
              </p:ext>
            </p:extLst>
          </p:nvPr>
        </p:nvGraphicFramePr>
        <p:xfrm>
          <a:off x="649451" y="1114726"/>
          <a:ext cx="9188232" cy="350457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377528"/>
                <a:gridCol w="3322104"/>
                <a:gridCol w="872150"/>
                <a:gridCol w="872150"/>
                <a:gridCol w="872150"/>
                <a:gridCol w="872150"/>
              </a:tblGrid>
              <a:tr h="700914">
                <a:tc>
                  <a:txBody>
                    <a:bodyPr/>
                    <a:lstStyle/>
                    <a:p>
                      <a:pPr algn="l" fontAlgn="b"/>
                      <a:endParaRPr lang="zh-CN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pring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ummer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utumn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Winter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</a:tr>
              <a:tr h="70091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ram-positive bacteria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varieties of genera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0.00 </a:t>
                      </a:r>
                      <a:endParaRPr lang="en-US" altLang="zh-CN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3.00 </a:t>
                      </a:r>
                      <a:endParaRPr lang="en-US" altLang="zh-CN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5.00 </a:t>
                      </a:r>
                      <a:endParaRPr lang="en-US" altLang="zh-CN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61.00 </a:t>
                      </a:r>
                      <a:endParaRPr lang="en-US" altLang="zh-CN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</a:tr>
              <a:tr h="70091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ercentage of total genera </a:t>
                      </a:r>
                      <a:r>
                        <a:rPr lang="en-US" sz="1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%, in </a:t>
                      </a:r>
                      <a:r>
                        <a:rPr lang="en-US" sz="1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21 genera)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7.27 </a:t>
                      </a:r>
                      <a:endParaRPr lang="en-US" altLang="zh-CN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2.09 </a:t>
                      </a:r>
                      <a:endParaRPr lang="en-US" altLang="zh-CN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8.23 </a:t>
                      </a:r>
                      <a:endParaRPr lang="en-US" altLang="zh-CN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1.71 </a:t>
                      </a:r>
                      <a:endParaRPr lang="en-US" altLang="zh-CN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</a:tr>
              <a:tr h="70091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ram-negative bacteria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varieties of genera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97.00 </a:t>
                      </a:r>
                      <a:endParaRPr lang="en-US" altLang="zh-CN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27.00 </a:t>
                      </a:r>
                      <a:endParaRPr lang="en-US" altLang="zh-CN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86.00 </a:t>
                      </a:r>
                      <a:endParaRPr lang="en-US" altLang="zh-CN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80.00 </a:t>
                      </a:r>
                      <a:endParaRPr lang="en-US" altLang="zh-CN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</a:tr>
              <a:tr h="70091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ercentage of total genera </a:t>
                      </a:r>
                      <a:r>
                        <a:rPr lang="en-US" sz="18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(%, in </a:t>
                      </a:r>
                      <a:r>
                        <a:rPr lang="en-US" sz="1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521 genera)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8.62 </a:t>
                      </a:r>
                      <a:endParaRPr lang="en-US" altLang="zh-CN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4.38 </a:t>
                      </a:r>
                      <a:endParaRPr lang="en-US" altLang="zh-CN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5.70 </a:t>
                      </a:r>
                      <a:endParaRPr lang="en-US" altLang="zh-CN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5.36 </a:t>
                      </a:r>
                      <a:endParaRPr lang="en-US" altLang="zh-CN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5546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6</TotalTime>
  <Words>77</Words>
  <Application>Microsoft Office PowerPoint</Application>
  <PresentationFormat>自定义</PresentationFormat>
  <Paragraphs>27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wzhu</dc:creator>
  <cp:lastModifiedBy>lenovon</cp:lastModifiedBy>
  <cp:revision>55</cp:revision>
  <dcterms:created xsi:type="dcterms:W3CDTF">2021-12-24T07:55:58Z</dcterms:created>
  <dcterms:modified xsi:type="dcterms:W3CDTF">2022-10-23T10:17:04Z</dcterms:modified>
</cp:coreProperties>
</file>